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6" r:id="rId7"/>
    <p:sldId id="268" r:id="rId8"/>
    <p:sldId id="269" r:id="rId9"/>
    <p:sldId id="270" r:id="rId10"/>
    <p:sldId id="271" r:id="rId11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Orta Stil 2 - Vurgu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Açık Stil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Açık Stil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Stil Yok, Tablo Kılavuz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til Yok, Kılavuz Yok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35A50D6-B5FE-4C5D-900B-7882E5E78D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04235445-6047-44D0-99D3-7375046E01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57DB3DAC-0256-4511-8C52-736055A6E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F2FBD0A-800C-4E82-B7BB-B073373DF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15875E4A-C2F7-4CAF-BC2E-FE1B3C284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676842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32ACDC58-D2D5-42BB-8713-14EE97E65D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18436DAA-DF28-4787-BA67-CAA3CB8BE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2F917A8-99E0-434A-865D-12FB39073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F74BA607-D424-4D72-BC21-786CF2D8B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F001E721-7EF3-444A-B7B4-09DC09601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73036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1874DF59-667F-42AE-9D0E-CAFC4AB555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E89CF36A-FCBF-4596-B569-CA0448336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56849E82-E8A4-44C8-87AC-DE00D3D1F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63D18EB8-06E4-4935-85F3-130CD8AFC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68B25480-2092-41A9-B7D8-F40AED006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12425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73FB16A-6B73-4AB0-9FD0-F067B2BB9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66A0BB6B-5AE7-48DF-BEA3-61E11894CE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0B5CE3D-FA02-4ACC-9CB7-A38611550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4A65E9A0-024A-4D9F-84F7-59A2FB922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76C5B45-88D6-497C-BF4D-AFCFC7464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87283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A986E37-FF0B-45C4-85EB-30E7FE4D9F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5744FAF5-62EF-401E-B29E-219D3742B8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07962EA4-B331-4440-99CA-0AD385E4C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554BDE6D-F73C-458E-A360-45FFD959D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6EFF67C-1B0C-4644-ABCA-BB03C485F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005397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596AAD6-B8A4-4742-ACC7-6FD93EC55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AE745855-6320-4872-8892-C2013AFC67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C37F33FE-9524-4C8F-8A94-BAD6EE1FF5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26845238-ED59-4461-87B9-780C240564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6778D730-2CB0-4284-89DA-B084ED70B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37B1870-00A9-4331-A18B-B0C28ACEB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531410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D35B9785-82D7-475A-887E-7A8B6952BD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215BD800-ADCE-4399-8354-F840EC94CA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F4BC0BFB-A351-45AC-B517-CB73E6D378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9CCA94BB-F3AB-4544-8256-7E16594EB7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64999846-6085-45A0-9D07-76BF3496B1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0851183C-63F0-4F2B-A1BB-24C1593AC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9FDFE512-289A-4433-A920-48D246803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07DA36B6-D218-4947-89F6-C8907961D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209802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5247349-5D35-461E-B100-3F29FFD543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D0F69BE2-1234-4D1F-9890-C1AA6B736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7B874303-9294-4792-A29D-A7201C135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6A5779FA-8F40-47A6-85A4-909A6520F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551643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763B3B32-E84F-4613-A75E-75FFDE1B9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6674B7E7-4012-4BC1-BC5E-188285F66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4526B219-3E71-4EB4-A548-BE7757ADD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14537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2D4F754-C002-49F4-9118-E913EC489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10DD4F96-9CD4-4C8A-BC11-DEF22C3B24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8FC66013-DE79-481F-A817-6369D3DBAC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7C2E6516-86E7-4C79-BE02-FE5C749B2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63A7F8DE-7E2B-47E6-9DA9-D7594BE00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326BBD14-C16A-4B89-887B-0ED200B7B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127191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4BB8A7F-302D-4775-A88D-D51A5C690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549BEC44-FFE0-4F09-8AEA-810A92703A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6499B0E7-FFD6-4941-B3DC-E35A380205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B2EBD06F-B045-4EFD-B988-A51BB2FAB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3D2D0AE0-5EF7-40D3-95CF-D63B3ECE0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8CAF9132-8959-498F-B68F-5A906CB54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633364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524BE31E-A7C8-4A30-A3D4-2F702E816F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82106E60-E8A2-4E15-9F4E-AB24B6C625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942776B7-9C96-4130-9C91-76D95054DF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6A737-A00A-40B7-ACA4-6DE4FEDCA945}" type="datetimeFigureOut">
              <a:rPr lang="tr-TR" smtClean="0"/>
              <a:t>18.05.2024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9E6C716-6BFF-4548-8D33-DB4F46FFDF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30AED348-0838-4334-8498-2FE3BFB844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3A9788-C33A-419E-9AC3-1CBE4853FC1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720430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lt Başlık 2">
            <a:extLst>
              <a:ext uri="{FF2B5EF4-FFF2-40B4-BE49-F238E27FC236}">
                <a16:creationId xmlns:a16="http://schemas.microsoft.com/office/drawing/2014/main" id="{345DEE2A-3C5F-4E92-A9ED-2F7B324969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38793" y="2912490"/>
            <a:ext cx="9144000" cy="1655762"/>
          </a:xfrm>
        </p:spPr>
        <p:txBody>
          <a:bodyPr>
            <a:normAutofit/>
          </a:bodyPr>
          <a:lstStyle/>
          <a:p>
            <a:r>
              <a:rPr lang="tr-TR" sz="4000" b="1" dirty="0"/>
              <a:t>Supplemental </a:t>
            </a:r>
            <a:r>
              <a:rPr lang="tr-TR" sz="4000" b="1" dirty="0" err="1"/>
              <a:t>Materials</a:t>
            </a:r>
            <a:endParaRPr lang="tr-TR" sz="4000" b="1" dirty="0"/>
          </a:p>
        </p:txBody>
      </p:sp>
    </p:spTree>
    <p:extLst>
      <p:ext uri="{BB962C8B-B14F-4D97-AF65-F5344CB8AC3E}">
        <p14:creationId xmlns:p14="http://schemas.microsoft.com/office/powerpoint/2010/main" val="10922614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Resim 1">
            <a:extLst>
              <a:ext uri="{FF2B5EF4-FFF2-40B4-BE49-F238E27FC236}">
                <a16:creationId xmlns:a16="http://schemas.microsoft.com/office/drawing/2014/main" id="{87A73F30-511D-0C8D-1964-035C0C9BED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1940"/>
          <a:stretch/>
        </p:blipFill>
        <p:spPr>
          <a:xfrm>
            <a:off x="385237" y="711036"/>
            <a:ext cx="4969517" cy="4816307"/>
          </a:xfrm>
          <a:prstGeom prst="rect">
            <a:avLst/>
          </a:prstGeom>
        </p:spPr>
      </p:pic>
      <p:sp>
        <p:nvSpPr>
          <p:cNvPr id="3" name="Metin kutusu 2">
            <a:extLst>
              <a:ext uri="{FF2B5EF4-FFF2-40B4-BE49-F238E27FC236}">
                <a16:creationId xmlns:a16="http://schemas.microsoft.com/office/drawing/2014/main" id="{E928C4E4-D936-957F-A6BA-9A703CBF1F62}"/>
              </a:ext>
            </a:extLst>
          </p:cNvPr>
          <p:cNvSpPr txBox="1"/>
          <p:nvPr/>
        </p:nvSpPr>
        <p:spPr>
          <a:xfrm>
            <a:off x="6374568" y="2158556"/>
            <a:ext cx="4166478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tr-TR" sz="18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tr-TR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tr-TR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ical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bstract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ure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miRNA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es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DNA:RNA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brids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ng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trol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tr-TR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ood</a:t>
            </a:r>
            <a:r>
              <a:rPr lang="tr-T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ssue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wn-regulation</a:t>
            </a:r>
            <a:r>
              <a:rPr lang="tr-TR" b="1" dirty="0">
                <a:solidFill>
                  <a:srgbClr val="C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-regulation</a:t>
            </a:r>
            <a:r>
              <a:rPr lang="tr-T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tr-TR" dirty="0"/>
          </a:p>
        </p:txBody>
      </p:sp>
    </p:spTree>
    <p:extLst>
      <p:ext uri="{BB962C8B-B14F-4D97-AF65-F5344CB8AC3E}">
        <p14:creationId xmlns:p14="http://schemas.microsoft.com/office/powerpoint/2010/main" val="3970218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o 11">
            <a:extLst>
              <a:ext uri="{FF2B5EF4-FFF2-40B4-BE49-F238E27FC236}">
                <a16:creationId xmlns:a16="http://schemas.microsoft.com/office/drawing/2014/main" id="{BF54E7C3-9BB8-4482-B903-3FA12E9DF1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440554"/>
              </p:ext>
            </p:extLst>
          </p:nvPr>
        </p:nvGraphicFramePr>
        <p:xfrm>
          <a:off x="2653260" y="1660734"/>
          <a:ext cx="6610662" cy="463513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37594">
                  <a:extLst>
                    <a:ext uri="{9D8B030D-6E8A-4147-A177-3AD203B41FA5}">
                      <a16:colId xmlns:a16="http://schemas.microsoft.com/office/drawing/2014/main" val="3191248595"/>
                    </a:ext>
                  </a:extLst>
                </a:gridCol>
                <a:gridCol w="1252275">
                  <a:extLst>
                    <a:ext uri="{9D8B030D-6E8A-4147-A177-3AD203B41FA5}">
                      <a16:colId xmlns:a16="http://schemas.microsoft.com/office/drawing/2014/main" val="249016927"/>
                    </a:ext>
                  </a:extLst>
                </a:gridCol>
                <a:gridCol w="3920793">
                  <a:extLst>
                    <a:ext uri="{9D8B030D-6E8A-4147-A177-3AD203B41FA5}">
                      <a16:colId xmlns:a16="http://schemas.microsoft.com/office/drawing/2014/main" val="2264322655"/>
                    </a:ext>
                  </a:extLst>
                </a:gridCol>
              </a:tblGrid>
              <a:tr h="38626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r>
                        <a:rPr lang="tr-TR" sz="1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ame</a:t>
                      </a:r>
                      <a:endParaRPr lang="tr-TR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</a:t>
                      </a:r>
                      <a:endParaRPr lang="tr-TR" sz="12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tr-TR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284958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9a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AGUUUUGCAUAGUUGCACUAC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4231850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GUGCAAAUCUAUGCAAAACUGA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6365412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9b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UUUUGCAGGUUUGCAUCCAGC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1578698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GUGCAAAUCCAUGCAAAACUGA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33093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499a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UAAGACUUGCAGUGAUGUUU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0553756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CAUCACAGCAAGUCUGUGCU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732894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26a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UUAUUACUUUUGGUACGCG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8005732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GUACCGUGAGUAAUAAUGCG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359681"/>
                  </a:ext>
                </a:extLst>
              </a:tr>
              <a:tr h="3862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361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UAUCAGAAUCUCCAGGGGUAC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150457"/>
                  </a:ext>
                </a:extLst>
              </a:tr>
              <a:tr h="3862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CCCCAGGUGUGAUUCUGAUUUGU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8679445"/>
                  </a:ext>
                </a:extLst>
              </a:tr>
              <a:tr h="386261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-miR-150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</a:t>
                      </a:r>
                      <a:endParaRPr lang="tr-TR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CUCCCAACCCUUGUACCAGUG</a:t>
                      </a:r>
                      <a:endParaRPr lang="tr-TR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13" marR="4221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103711"/>
                  </a:ext>
                </a:extLst>
              </a:tr>
            </a:tbl>
          </a:graphicData>
        </a:graphic>
      </p:graphicFrame>
      <p:sp>
        <p:nvSpPr>
          <p:cNvPr id="15" name="Metin kutusu 14">
            <a:extLst>
              <a:ext uri="{FF2B5EF4-FFF2-40B4-BE49-F238E27FC236}">
                <a16:creationId xmlns:a16="http://schemas.microsoft.com/office/drawing/2014/main" id="{2F9E31F5-8DC3-4CBE-B512-D2E17EC2A768}"/>
              </a:ext>
            </a:extLst>
          </p:cNvPr>
          <p:cNvSpPr txBox="1"/>
          <p:nvPr/>
        </p:nvSpPr>
        <p:spPr>
          <a:xfrm>
            <a:off x="4605727" y="1052022"/>
            <a:ext cx="6093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tr-TR" b="1" dirty="0" err="1"/>
              <a:t>Table</a:t>
            </a:r>
            <a:r>
              <a:rPr lang="tr-TR" b="1" dirty="0"/>
              <a:t> S1: </a:t>
            </a:r>
            <a:r>
              <a:rPr lang="tr-TR" dirty="0" err="1"/>
              <a:t>miRNAs</a:t>
            </a:r>
            <a:r>
              <a:rPr lang="tr-TR" dirty="0"/>
              <a:t>' </a:t>
            </a:r>
            <a:r>
              <a:rPr lang="tr-TR" dirty="0" err="1"/>
              <a:t>sequences</a:t>
            </a:r>
            <a:endParaRPr lang="tr-TR" dirty="0"/>
          </a:p>
        </p:txBody>
      </p:sp>
    </p:spTree>
    <p:extLst>
      <p:ext uri="{BB962C8B-B14F-4D97-AF65-F5344CB8AC3E}">
        <p14:creationId xmlns:p14="http://schemas.microsoft.com/office/powerpoint/2010/main" val="29241677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o 1">
            <a:extLst>
              <a:ext uri="{FF2B5EF4-FFF2-40B4-BE49-F238E27FC236}">
                <a16:creationId xmlns:a16="http://schemas.microsoft.com/office/drawing/2014/main" id="{17BC6FEE-9217-4F4C-AFDA-6169045DB7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784513"/>
              </p:ext>
            </p:extLst>
          </p:nvPr>
        </p:nvGraphicFramePr>
        <p:xfrm>
          <a:off x="3043003" y="1740348"/>
          <a:ext cx="6475752" cy="459963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515146">
                  <a:extLst>
                    <a:ext uri="{9D8B030D-6E8A-4147-A177-3AD203B41FA5}">
                      <a16:colId xmlns:a16="http://schemas.microsoft.com/office/drawing/2014/main" val="1505153939"/>
                    </a:ext>
                  </a:extLst>
                </a:gridCol>
                <a:gridCol w="1003202">
                  <a:extLst>
                    <a:ext uri="{9D8B030D-6E8A-4147-A177-3AD203B41FA5}">
                      <a16:colId xmlns:a16="http://schemas.microsoft.com/office/drawing/2014/main" val="2938044293"/>
                    </a:ext>
                  </a:extLst>
                </a:gridCol>
                <a:gridCol w="3957404">
                  <a:extLst>
                    <a:ext uri="{9D8B030D-6E8A-4147-A177-3AD203B41FA5}">
                      <a16:colId xmlns:a16="http://schemas.microsoft.com/office/drawing/2014/main" val="332251021"/>
                    </a:ext>
                  </a:extLst>
                </a:gridCol>
              </a:tblGrid>
              <a:tr h="25596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</a:t>
                      </a:r>
                      <a:r>
                        <a:rPr lang="tr-TR" sz="1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</a:t>
                      </a:r>
                      <a:r>
                        <a:rPr lang="tr-TR" sz="1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r>
                        <a:rPr lang="tr-TR" sz="16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ame</a:t>
                      </a:r>
                      <a:endParaRPr lang="tr-TR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</a:t>
                      </a:r>
                      <a:endParaRPr lang="tr-TR" sz="14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tr-TR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06772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-miR-19a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AGCCAACTGTCCTGTTA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8670665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CATTGCGACAAATCCC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6451425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-miR-19b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AAGTGCTCCTTCTGGC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432517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AGGGCTGCAAACACAAC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894489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-miR-499a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TCACAAGGTGAGGTCCA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742149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CCTACCCAGGCCTTACT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5059550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-miR-126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GTTGTAAGGATGCTGGC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3588559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GGGTGTAACAGACCCAC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59851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miR-19a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CCCTCTGTTAGTTTTGCAT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1903963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GCCACCATCAGTTTTG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2895857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miR-19b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GTTTTGCAGGTTTGCATCCAG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3942894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CACAGTCAGTTTTGCATGG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752418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miR-499a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GGGCAGCTGTTAAGAC  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303669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AGCAGCACAGACTTG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1793088"/>
                  </a:ext>
                </a:extLst>
              </a:tr>
              <a:tr h="255961">
                <a:tc rowSpan="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miR-126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CAGCACATTATTACTTT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445411"/>
                  </a:ext>
                </a:extLst>
              </a:tr>
              <a:tr h="25596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tr-TR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tr-TR" sz="16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GCGCATTATTACTCACG</a:t>
                      </a:r>
                      <a:endParaRPr lang="tr-TR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9798" marR="29798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9538847"/>
                  </a:ext>
                </a:extLst>
              </a:tr>
            </a:tbl>
          </a:graphicData>
        </a:graphic>
      </p:graphicFrame>
      <p:sp>
        <p:nvSpPr>
          <p:cNvPr id="5" name="Metin kutusu 4">
            <a:extLst>
              <a:ext uri="{FF2B5EF4-FFF2-40B4-BE49-F238E27FC236}">
                <a16:creationId xmlns:a16="http://schemas.microsoft.com/office/drawing/2014/main" id="{FA86FE4A-5D09-4831-9125-7BD5FCC1079B}"/>
              </a:ext>
            </a:extLst>
          </p:cNvPr>
          <p:cNvSpPr txBox="1"/>
          <p:nvPr/>
        </p:nvSpPr>
        <p:spPr>
          <a:xfrm>
            <a:off x="4313420" y="1201923"/>
            <a:ext cx="60935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tr-T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re-miRNAs' sequences</a:t>
            </a:r>
            <a:endParaRPr lang="tr-T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4507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9D7A27C9-4EA4-4D87-BF9E-6C0E083AFD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21114" y="71952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tr-TR"/>
          </a:p>
        </p:txBody>
      </p:sp>
      <p:sp>
        <p:nvSpPr>
          <p:cNvPr id="6" name="Metin kutusu 5">
            <a:extLst>
              <a:ext uri="{FF2B5EF4-FFF2-40B4-BE49-F238E27FC236}">
                <a16:creationId xmlns:a16="http://schemas.microsoft.com/office/drawing/2014/main" id="{5E107621-D16A-4584-9232-46AB3F9A6BE3}"/>
              </a:ext>
            </a:extLst>
          </p:cNvPr>
          <p:cNvSpPr txBox="1"/>
          <p:nvPr/>
        </p:nvSpPr>
        <p:spPr>
          <a:xfrm>
            <a:off x="0" y="5854969"/>
            <a:ext cx="12192000" cy="1003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1: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pocampus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F0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ration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'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19a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 (B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'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499a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.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ll data were expressed with mean and ±SD; (N)=5 for F0 mir19a-5p group, (N)=5 for F0 miR19a-3p grou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N)=5 for F0 mir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9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a-5p group, (N)=5 for F0 </a:t>
            </a:r>
            <a:r>
              <a:rPr lang="en-US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9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a-3p group and (N)=5 for control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;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x-axis illustrates the groups formed by microinjection with mi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a-5p/-3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A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tr-TR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9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a-5p/-3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B)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longside the control group. The y-axis represents the expressions of the miRNAs utilized in the study.).</a:t>
            </a:r>
            <a:endParaRPr lang="tr-TR" sz="105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Resim 3">
            <a:extLst>
              <a:ext uri="{FF2B5EF4-FFF2-40B4-BE49-F238E27FC236}">
                <a16:creationId xmlns:a16="http://schemas.microsoft.com/office/drawing/2014/main" id="{8AB3F55B-2BB5-4D3A-8BB7-A27E1EB7C1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916" y="200320"/>
            <a:ext cx="12192000" cy="5516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26551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etin kutusu 3">
            <a:extLst>
              <a:ext uri="{FF2B5EF4-FFF2-40B4-BE49-F238E27FC236}">
                <a16:creationId xmlns:a16="http://schemas.microsoft.com/office/drawing/2014/main" id="{33116DDC-5F10-489D-9E6E-8BC79F731136}"/>
              </a:ext>
            </a:extLst>
          </p:cNvPr>
          <p:cNvSpPr txBox="1"/>
          <p:nvPr/>
        </p:nvSpPr>
        <p:spPr>
          <a:xfrm>
            <a:off x="6118225" y="2797417"/>
            <a:ext cx="6093500" cy="3634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2: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-miRNAs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pocampus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F0 </a:t>
            </a:r>
            <a:r>
              <a:rPr lang="tr-TR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ration</a:t>
            </a:r>
            <a:r>
              <a:rPr lang="tr-TR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-miRNAs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19a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 (B)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e-miRNAs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499a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.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ll data were expressed with mean and ±SD; (N)=5 for F0 mir19a-5p group, (N)=5 for F0 miR19a-3p group, (N)=5 for F0 mir499a-5p group, (N)=5 for F0 miR499a-3p group and (N)=5 for control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x-axis illustrates the groups formed by microinjection with mi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a-5p/-3p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A) </a:t>
            </a:r>
            <a:r>
              <a:rPr lang="tr-TR" sz="18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tr-TR" sz="18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9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a-5p/-3p</a:t>
            </a:r>
            <a:r>
              <a:rPr lang="tr-TR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B)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longside the control group. The y-axis represents the expressions of the miRNAs utilized in the study.).</a:t>
            </a:r>
            <a:endParaRPr lang="tr-TR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Resim 1">
            <a:extLst>
              <a:ext uri="{FF2B5EF4-FFF2-40B4-BE49-F238E27FC236}">
                <a16:creationId xmlns:a16="http://schemas.microsoft.com/office/drawing/2014/main" id="{A9B49AF6-0D0C-4FFE-9672-00A4F92B65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1873"/>
            <a:ext cx="6118225" cy="6434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2028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C1EAFF25-FC73-4B2F-8CCC-FA94F710EE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tr-TR"/>
          </a:p>
        </p:txBody>
      </p:sp>
      <p:pic>
        <p:nvPicPr>
          <p:cNvPr id="5121" name="Picture 1">
            <a:extLst>
              <a:ext uri="{FF2B5EF4-FFF2-40B4-BE49-F238E27FC236}">
                <a16:creationId xmlns:a16="http://schemas.microsoft.com/office/drawing/2014/main" id="{78C8F44D-4DE5-47E4-9325-0F0C213AD5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2"/>
            <a:ext cx="6108700" cy="55986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>
            <a:extLst>
              <a:ext uri="{FF2B5EF4-FFF2-40B4-BE49-F238E27FC236}">
                <a16:creationId xmlns:a16="http://schemas.microsoft.com/office/drawing/2014/main" id="{A49831C5-45AF-4963-9C55-AE7054AAC1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8700" y="0"/>
            <a:ext cx="6119812" cy="55986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Metin kutusu 6">
            <a:extLst>
              <a:ext uri="{FF2B5EF4-FFF2-40B4-BE49-F238E27FC236}">
                <a16:creationId xmlns:a16="http://schemas.microsoft.com/office/drawing/2014/main" id="{D181AC56-2F56-4F5D-A8D0-774955C35410}"/>
              </a:ext>
            </a:extLst>
          </p:cNvPr>
          <p:cNvSpPr txBox="1"/>
          <p:nvPr/>
        </p:nvSpPr>
        <p:spPr>
          <a:xfrm>
            <a:off x="-18257" y="5884010"/>
            <a:ext cx="12228513" cy="1003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3: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sperm in F0 </a:t>
            </a:r>
            <a:r>
              <a:rPr lang="tr-TR" sz="14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ration</a:t>
            </a:r>
            <a:r>
              <a:rPr lang="tr-T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'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19a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NA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'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ion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 miR-499a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injected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u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5p/3p)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ll data were expressed with mean and ±SD; (N)=5 for F0 mir19a-5p group, (N)=5 for F0 miR19a-3p group, (N)=5 for F0 mir499a-5p group, (N)=5 for F0 miR499a-3p group and (N)=5 for control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x-axis illustrates the groups formed by microinjection with mi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a-5p/-3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A) </a:t>
            </a:r>
            <a:r>
              <a:rPr lang="tr-TR" sz="1400" b="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-</a:t>
            </a:r>
            <a:r>
              <a:rPr lang="tr-TR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9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a-5p/-3p</a:t>
            </a:r>
            <a:r>
              <a:rPr lang="tr-TR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n B) 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longside the control group. The y-axis represents the expressions of the miRNAs utilized in the study.).</a:t>
            </a:r>
            <a:endParaRPr lang="tr-TR" sz="105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48569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Resim 3">
            <a:extLst>
              <a:ext uri="{FF2B5EF4-FFF2-40B4-BE49-F238E27FC236}">
                <a16:creationId xmlns:a16="http://schemas.microsoft.com/office/drawing/2014/main" id="{374B8D7F-608C-2657-6918-38FD0079DC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1667"/>
          <a:stretch/>
        </p:blipFill>
        <p:spPr>
          <a:xfrm>
            <a:off x="203990" y="0"/>
            <a:ext cx="7115385" cy="6858000"/>
          </a:xfrm>
          <a:prstGeom prst="rect">
            <a:avLst/>
          </a:prstGeom>
        </p:spPr>
      </p:pic>
      <p:sp>
        <p:nvSpPr>
          <p:cNvPr id="2" name="Metin kutusu 1">
            <a:extLst>
              <a:ext uri="{FF2B5EF4-FFF2-40B4-BE49-F238E27FC236}">
                <a16:creationId xmlns:a16="http://schemas.microsoft.com/office/drawing/2014/main" id="{B83304A3-5428-1C5A-7FB4-23D9F1C2FFE3}"/>
              </a:ext>
            </a:extLst>
          </p:cNvPr>
          <p:cNvSpPr txBox="1"/>
          <p:nvPr/>
        </p:nvSpPr>
        <p:spPr>
          <a:xfrm>
            <a:off x="7587916" y="2783123"/>
            <a:ext cx="4477059" cy="21258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7313" algn="just">
              <a:lnSpc>
                <a:spcPct val="150000"/>
              </a:lnSpc>
            </a:pPr>
            <a:r>
              <a:rPr lang="en-US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4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aphical abstract of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i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Pre- and mature miRNA expression level changes comparing with control group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wn-regulation</a:t>
            </a:r>
            <a:r>
              <a:rPr lang="tr-TR" b="1" dirty="0">
                <a:solidFill>
                  <a:srgbClr val="C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-regulation</a:t>
            </a:r>
            <a:r>
              <a:rPr lang="tr-T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tr-TR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99071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Resim 4">
            <a:extLst>
              <a:ext uri="{FF2B5EF4-FFF2-40B4-BE49-F238E27FC236}">
                <a16:creationId xmlns:a16="http://schemas.microsoft.com/office/drawing/2014/main" id="{AFE4DE6A-CB3C-1B45-E9FF-82E8E88F07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4444"/>
          <a:stretch/>
        </p:blipFill>
        <p:spPr>
          <a:xfrm>
            <a:off x="0" y="764498"/>
            <a:ext cx="7989757" cy="4736892"/>
          </a:xfrm>
          <a:prstGeom prst="rect">
            <a:avLst/>
          </a:prstGeom>
        </p:spPr>
      </p:pic>
      <p:sp>
        <p:nvSpPr>
          <p:cNvPr id="2" name="Metin kutusu 1">
            <a:extLst>
              <a:ext uri="{FF2B5EF4-FFF2-40B4-BE49-F238E27FC236}">
                <a16:creationId xmlns:a16="http://schemas.microsoft.com/office/drawing/2014/main" id="{3BFCB9EE-F126-BB66-1102-D3AA9391279D}"/>
              </a:ext>
            </a:extLst>
          </p:cNvPr>
          <p:cNvSpPr txBox="1"/>
          <p:nvPr/>
        </p:nvSpPr>
        <p:spPr>
          <a:xfrm>
            <a:off x="8154649" y="2274251"/>
            <a:ext cx="3927423" cy="25413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5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aphical abstract of mature miRNA expression level changes comparing with control group in sperm tissue</a:t>
            </a:r>
            <a:r>
              <a:rPr lang="tr-TR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wn-regulation</a:t>
            </a:r>
            <a:r>
              <a:rPr lang="tr-TR" b="1" dirty="0">
                <a:solidFill>
                  <a:srgbClr val="C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-regulation</a:t>
            </a:r>
            <a:r>
              <a:rPr lang="tr-T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tr-TR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3973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Metin kutusu 2">
            <a:extLst>
              <a:ext uri="{FF2B5EF4-FFF2-40B4-BE49-F238E27FC236}">
                <a16:creationId xmlns:a16="http://schemas.microsoft.com/office/drawing/2014/main" id="{36A27D3C-948B-D13B-86E7-7B1100446DCA}"/>
              </a:ext>
            </a:extLst>
          </p:cNvPr>
          <p:cNvSpPr txBox="1"/>
          <p:nvPr/>
        </p:nvSpPr>
        <p:spPr>
          <a:xfrm>
            <a:off x="7813623" y="2735198"/>
            <a:ext cx="4166478" cy="25413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8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6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raphical abstract of mature miRNA expression level changes in DNA: RNA hybrids comparing with control group in blood, hippocampus, and sperm tissue 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sz="1800" b="1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sz="1800" b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wn-regulation</a:t>
            </a:r>
            <a:r>
              <a:rPr lang="tr-TR" b="1" dirty="0">
                <a:solidFill>
                  <a:srgbClr val="C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</a:t>
            </a:r>
            <a:r>
              <a:rPr lang="tr-TR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sz="1800" b="1" dirty="0" err="1">
                <a:solidFill>
                  <a:srgbClr val="00B05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</a:t>
            </a:r>
            <a:r>
              <a:rPr lang="tr-TR" b="1" dirty="0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tr-TR" b="1" dirty="0" err="1">
                <a:solidFill>
                  <a:srgbClr val="00B05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-regulation</a:t>
            </a:r>
            <a:r>
              <a:rPr lang="tr-TR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tr-TR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Resim 4">
            <a:extLst>
              <a:ext uri="{FF2B5EF4-FFF2-40B4-BE49-F238E27FC236}">
                <a16:creationId xmlns:a16="http://schemas.microsoft.com/office/drawing/2014/main" id="{896039CD-D565-66DE-2619-5851F3EF21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9357"/>
          <a:stretch/>
        </p:blipFill>
        <p:spPr>
          <a:xfrm>
            <a:off x="211899" y="122827"/>
            <a:ext cx="7485438" cy="6387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6206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675</Words>
  <Application>Microsoft Office PowerPoint</Application>
  <PresentationFormat>Geniş ekran</PresentationFormat>
  <Paragraphs>84</Paragraphs>
  <Slides>10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5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Palatino Linotype</vt:lpstr>
      <vt:lpstr>Times New Roman</vt:lpstr>
      <vt:lpstr>Office Teması</vt:lpstr>
      <vt:lpstr>PowerPoint Sunusu</vt:lpstr>
      <vt:lpstr>PowerPoint Sunusu</vt:lpstr>
      <vt:lpstr>PowerPoint Sunusu</vt:lpstr>
      <vt:lpstr>PowerPoint Sunusu</vt:lpstr>
      <vt:lpstr>PowerPoint Sunusu</vt:lpstr>
      <vt:lpstr>PowerPoint Sunusu</vt:lpstr>
      <vt:lpstr>PowerPoint Sunusu</vt:lpstr>
      <vt:lpstr>PowerPoint Sunusu</vt:lpstr>
      <vt:lpstr>PowerPoint Sunusu</vt:lpstr>
      <vt:lpstr>PowerPoint Sunus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Zeynep YILMAZ</dc:creator>
  <cp:lastModifiedBy>Zeynep Yılmaz</cp:lastModifiedBy>
  <cp:revision>9</cp:revision>
  <dcterms:created xsi:type="dcterms:W3CDTF">2021-12-27T13:25:40Z</dcterms:created>
  <dcterms:modified xsi:type="dcterms:W3CDTF">2024-05-18T17:42:31Z</dcterms:modified>
</cp:coreProperties>
</file>